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0A1B6-8BCE-480E-8A74-32F0657E38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8D53A-5A6B-4A37-B04E-481214797F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F2B0B-553F-471F-BEB6-EF8B31F262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57732-9A5E-42AF-90F4-970CEEDDBA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E960A-E552-42FD-805D-16F597ABDE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FC21A-2119-44C0-9FF8-59AD9B3FA3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EACC0-A037-4001-A54F-B9D36471C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2907C-2C8D-4FA5-A8D6-F4C66B6A44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4F621-7B0D-4C7E-8ECF-D8C2CC9DB7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D8B2C-2C89-47D9-8028-B5A32DBA59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225A0-F78E-4EFF-A3A6-05B57F9868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7BBB0-AEF0-4AE0-8C76-78E47D422D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929D67-A066-4A83-8D93-55E541419E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97080" y="552600"/>
          <a:ext cx="4751280" cy="6261120"/>
        </p:xfrm>
        <a:graphic>
          <a:graphicData uri="http://schemas.openxmlformats.org/drawingml/2006/table">
            <a:tbl>
              <a:tblPr/>
              <a:tblGrid>
                <a:gridCol w="874440"/>
                <a:gridCol w="2016000"/>
                <a:gridCol w="1860840"/>
              </a:tblGrid>
              <a:tr h="19980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romosom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 (transcrip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RAS (NM_002524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 3,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DR2 (NM_006182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 8, 12, 13, 14, 15, 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F3A (NM_002107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K (NM_004304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, 23, 24, 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DH1 (NM_005896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0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RBB4  (NM_005235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 4, 6, 7, 8, 9, 10, 12, 15, 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NNB1 (NM_001904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IK3CA (NM_006218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, 14, 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rowSpan="4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GFR3 (NM_000142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, 9, 14, 16, 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GFRA (NM_006206.4)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, 14, 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IT (NM_000222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, 9, 11, 13, 14, 17, 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BXW7 (NM_033632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 8, 9, 10, 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IST1H3B (NM_003537.3)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OS1 (NM_002944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, 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GFR (NM_005228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, 18, 19, 20, 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T (NM_001127500.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 14, 15, 16, 17, 18, 19, 2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RAF (NM_004333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, 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GFR1  (NM_023110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, 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TCH1 (NM_017617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, 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EN (NM_000314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 3, 6, 7, 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GFR2 (NM_000141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, 7, 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RAS (NM_005343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 3,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RAS (NM_004985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 3,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KT1 (NM_005163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P2K1 (NM_002755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DH2 (NM_002168.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P 53 (NM_000546.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 3, 4, 5, 6, 7, 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RBB2 (NM_004448.3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, 20, 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MAD4  (NM_005359.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, 5, 7, 8, 9, 10, 11, 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K11 (NM_000455.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, 5, 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4-06T12:47:47Z</dcterms:created>
  <dc:creator>chu</dc:creator>
  <dc:description/>
  <dc:language>en-US</dc:language>
  <cp:lastModifiedBy>chu</cp:lastModifiedBy>
  <cp:lastPrinted>2017-04-07T10:11:10Z</cp:lastPrinted>
  <dcterms:modified xsi:type="dcterms:W3CDTF">2018-02-16T14:43:53Z</dcterms:modified>
  <cp:revision>109</cp:revision>
  <dc:subject/>
  <dc:title>Diapositive 1</dc:title>
</cp:coreProperties>
</file>